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2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2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" userId="845497175cb2f617" providerId="LiveId" clId="{1E5D1351-58D1-4D10-A127-2278D7545E5C}"/>
    <pc:docChg chg="modSld">
      <pc:chgData name="健" userId="845497175cb2f617" providerId="LiveId" clId="{1E5D1351-58D1-4D10-A127-2278D7545E5C}" dt="2023-07-27T07:28:28.541" v="25" actId="20577"/>
      <pc:docMkLst>
        <pc:docMk/>
      </pc:docMkLst>
      <pc:sldChg chg="delSp modSp mod">
        <pc:chgData name="健" userId="845497175cb2f617" providerId="LiveId" clId="{1E5D1351-58D1-4D10-A127-2278D7545E5C}" dt="2023-07-27T07:28:28.541" v="25" actId="20577"/>
        <pc:sldMkLst>
          <pc:docMk/>
          <pc:sldMk cId="0" sldId="626"/>
        </pc:sldMkLst>
        <pc:spChg chg="mod">
          <ac:chgData name="健" userId="845497175cb2f617" providerId="LiveId" clId="{1E5D1351-58D1-4D10-A127-2278D7545E5C}" dt="2023-07-27T07:28:28.541" v="25" actId="20577"/>
          <ac:spMkLst>
            <pc:docMk/>
            <pc:sldMk cId="0" sldId="626"/>
            <ac:spMk id="20" creationId="{6482D18D-ED3C-CAE7-69B0-2B22207384E4}"/>
          </ac:spMkLst>
        </pc:spChg>
        <pc:spChg chg="del mod">
          <ac:chgData name="健" userId="845497175cb2f617" providerId="LiveId" clId="{1E5D1351-58D1-4D10-A127-2278D7545E5C}" dt="2023-07-27T07:28:20.103" v="21"/>
          <ac:spMkLst>
            <pc:docMk/>
            <pc:sldMk cId="0" sldId="626"/>
            <ac:spMk id="21" creationId="{713D1FEC-796A-B7C0-DAD0-7027E4865BD1}"/>
          </ac:spMkLst>
        </pc:spChg>
        <pc:spChg chg="mod">
          <ac:chgData name="健" userId="845497175cb2f617" providerId="LiveId" clId="{1E5D1351-58D1-4D10-A127-2278D7545E5C}" dt="2023-07-27T07:24:04.766" v="0" actId="1076"/>
          <ac:spMkLst>
            <pc:docMk/>
            <pc:sldMk cId="0" sldId="626"/>
            <ac:spMk id="36875" creationId="{B4CBA58B-C98E-33E0-BCCE-BCD4E0FAA8AE}"/>
          </ac:spMkLst>
        </pc:spChg>
        <pc:spChg chg="mod">
          <ac:chgData name="健" userId="845497175cb2f617" providerId="LiveId" clId="{1E5D1351-58D1-4D10-A127-2278D7545E5C}" dt="2023-07-27T07:27:45.844" v="1" actId="1076"/>
          <ac:spMkLst>
            <pc:docMk/>
            <pc:sldMk cId="0" sldId="626"/>
            <ac:spMk id="36879" creationId="{9E04761E-C9C1-0BA3-5946-4BE51D098E6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FC026D-4988-4B19-B559-DBB81CB4945C}" type="datetimeFigureOut">
              <a:rPr kumimoji="1" lang="ja-JP" altLang="en-US" smtClean="0"/>
              <a:t>2023/9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38DA3-F0D2-4AF9-85E1-1FCE5F4C8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90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Slide Image Placeholder 1">
            <a:extLst>
              <a:ext uri="{FF2B5EF4-FFF2-40B4-BE49-F238E27FC236}">
                <a16:creationId xmlns:a16="http://schemas.microsoft.com/office/drawing/2014/main" id="{0AD10A40-AFA2-1297-375D-D632CC24F8BF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7891" name="Notes Placeholder 2">
            <a:extLst>
              <a:ext uri="{FF2B5EF4-FFF2-40B4-BE49-F238E27FC236}">
                <a16:creationId xmlns:a16="http://schemas.microsoft.com/office/drawing/2014/main" id="{5C2F701C-B6B0-5D5A-96FD-AD26F8396F4D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>
              <a:solidFill>
                <a:srgbClr val="FF0000"/>
              </a:solidFill>
            </a:endParaRPr>
          </a:p>
        </p:txBody>
      </p:sp>
      <p:sp>
        <p:nvSpPr>
          <p:cNvPr id="37892" name="Slide Number Placeholder 3">
            <a:extLst>
              <a:ext uri="{FF2B5EF4-FFF2-40B4-BE49-F238E27FC236}">
                <a16:creationId xmlns:a16="http://schemas.microsoft.com/office/drawing/2014/main" id="{0A9CA88B-CE15-880E-3404-06A1BF5BDC06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555E976-2780-4035-95E2-67C955B7EB54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F4E6DA-E745-35F7-89E6-E347AD3BF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0A8E4F68-7FDB-4AF1-A458-49350E626BD4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C18907-761F-6FC5-8304-56D2032FC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FE326-E982-2801-A4E4-A9156243B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48BD2DC3-9F44-4BBC-940B-EB31790CBB4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28207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202FE0-32B1-39D0-DE26-A9ADCB5D7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A7027FF-EFB2-44B2-93F1-99759ADDC15A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668AA3-3BE3-38B7-47FE-AF30694E0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CC5624-9FAF-E6D6-80C3-2CF57C59C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0D1F98D0-D753-492B-9E0E-18859E771A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8497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43"/>
            <a:ext cx="27432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43"/>
            <a:ext cx="80264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A724C0-BFD7-31A4-7A9A-5C641C925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C450CAE5-67FC-4D2C-AC67-4047EA5BC620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F82656-5269-F060-AFB3-86477F941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B19F98-D886-4C95-963B-91128151A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5277312-F62B-420D-A892-50C91787E6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633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36A464-8339-4FD0-FD13-29669F18D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1E68D03D-FF39-45F9-9B25-AF842284E23D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83DC29-53D2-B0CF-36E9-7055D48B0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87E2C9-CEEB-5A6B-010B-53EC4341E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672FC40-447F-4F51-9AF6-13875E8DF6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7659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5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81612F-4D65-55AA-C855-0B871F0D8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AD90DBB-7F35-4357-A384-6CE8F95DF3C9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693BC5-C38E-3ECA-C50F-2A023EB9C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36F9BB-CABD-0514-A940-6EE449A84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94750D7-755F-4BFE-B622-B7808FC8516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0102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E7E42C-395E-B887-B391-951688288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77C01132-489D-4552-8D3D-B81DED5225E4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B8D8F1-615D-2E08-C868-DE67EF72E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F9FB90F-3746-D1E1-0433-1A20F77EB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A4ECC1B-2B49-4986-914F-75D1EDD432C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54887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0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9EA90F5-EDE2-EFA7-7ECE-DCA8B9BA6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A8EA810-D6E5-44BC-A0E7-A811DAE8DC10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24C7D3-2897-0D32-8ED4-F78A9A334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A1EB67C-A185-7DB7-31F4-000771435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369457E3-1C3A-44E5-B1EC-DA998CC4046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58511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E9D86AF-F39E-DE4D-1972-B16887D0C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3CFC698-3CEB-4958-AC77-61C4EEA3E956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ADF98AB-C61C-0CFA-ABA9-90E3A041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183E167-3A59-C759-0CC3-BC1B8D0C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BF01126C-3D25-4444-9FEC-303B67EC15C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2038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9DAF865-D9D8-0DAF-9BAA-5641F981A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9FB0D41-A093-4EAA-B75F-6394C0C2FA9C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FE3A2AB-7225-E02C-9B7B-61180958C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7CAE267-BDE7-D9B3-1A40-3D1A47B43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6BFF13A-9F48-42B5-A1A6-EB5281602E8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95898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5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5E0F46-E608-CE4C-A1A5-BC9E07B32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B107569-20DB-413E-AB2E-3C3A1B5DBC94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A9089E-B983-BC29-73F7-A83D74F4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B4F61D-A884-015C-46B6-AF28E6A44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2496869-E1E1-4F4F-9908-A4BF6D33F7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75768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0C971D3-2CD3-BC6E-EF06-60465C172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DB95304F-9F3A-4779-8CA2-C92E67292FA9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77F925-0626-1BC6-FFC8-4D6DE5C03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1AB5A6-461B-52EB-14EF-B6D3BEE7F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ECD5D206-E4BD-4BFB-B684-A2A2E92B02D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67888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2EA24FA0-9968-D6AC-7AD5-5DB30B3C0AF5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3E9927DA-8078-AAB0-49D7-DB82B35A09E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3D7998-E922-DF0D-7ED2-002C318803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38FFB841-94FC-4D13-8D4A-881E0C1BA1F7}" type="datetimeFigureOut">
              <a:rPr lang="ja-JP" altLang="en-US"/>
              <a:pPr>
                <a:defRPr/>
              </a:pPr>
              <a:t>2023/9/8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FDE345-93BB-0277-6A41-1681D57C92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006E4A-4CEC-6058-A1C7-BD801ED0EC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31BBD180-B25F-4BEA-9405-FB405435755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51543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5pPr>
      <a:lvl6pPr marL="457189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6pPr>
      <a:lvl7pPr marL="914377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7pPr>
      <a:lvl8pPr marL="1371566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8pPr>
      <a:lvl9pPr marL="1828754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9pPr>
    </p:titleStyle>
    <p:bodyStyle>
      <a:lvl1pPr marL="341313" indent="-3413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8" name="Picture 25" descr="http://ebcdih.mc.vanderbilt.edu/dih/dih_files/snapshots/snapshot-190819-141422-2030514236.jpg">
            <a:extLst>
              <a:ext uri="{FF2B5EF4-FFF2-40B4-BE49-F238E27FC236}">
                <a16:creationId xmlns:a16="http://schemas.microsoft.com/office/drawing/2014/main" id="{BF8AFBF3-5979-30F4-5C18-DC6BBD85C3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648" t="52946" r="-24075" b="-1022"/>
          <a:stretch>
            <a:fillRect/>
          </a:stretch>
        </p:blipFill>
        <p:spPr bwMode="auto">
          <a:xfrm>
            <a:off x="1037152" y="116617"/>
            <a:ext cx="6026150" cy="3021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69" name="Rectangle 10">
            <a:extLst>
              <a:ext uri="{FF2B5EF4-FFF2-40B4-BE49-F238E27FC236}">
                <a16:creationId xmlns:a16="http://schemas.microsoft.com/office/drawing/2014/main" id="{DB03C2AF-4445-3B46-DAC7-4F25833916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4694" y="2801376"/>
            <a:ext cx="63511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H2009</a:t>
            </a:r>
          </a:p>
        </p:txBody>
      </p:sp>
      <p:pic>
        <p:nvPicPr>
          <p:cNvPr id="36870" name="Picture 27" descr="http://ebcdih.mc.vanderbilt.edu/dih/dih_files/snapshots/snapshot-190819-141848-714428145.jpg">
            <a:extLst>
              <a:ext uri="{FF2B5EF4-FFF2-40B4-BE49-F238E27FC236}">
                <a16:creationId xmlns:a16="http://schemas.microsoft.com/office/drawing/2014/main" id="{9AC8CB87-9113-CC05-A3D5-266E37EAF9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05" t="53069"/>
          <a:stretch>
            <a:fillRect/>
          </a:stretch>
        </p:blipFill>
        <p:spPr bwMode="auto">
          <a:xfrm>
            <a:off x="4493139" y="129317"/>
            <a:ext cx="3071813" cy="2949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71" name="Rectangle 14">
            <a:extLst>
              <a:ext uri="{FF2B5EF4-FFF2-40B4-BE49-F238E27FC236}">
                <a16:creationId xmlns:a16="http://schemas.microsoft.com/office/drawing/2014/main" id="{690D5A53-8F70-5EF4-6C96-D515A86335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3314" y="2807456"/>
            <a:ext cx="63511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H1299</a:t>
            </a:r>
          </a:p>
        </p:txBody>
      </p:sp>
      <p:sp>
        <p:nvSpPr>
          <p:cNvPr id="36872" name="Rectangle 6">
            <a:extLst>
              <a:ext uri="{FF2B5EF4-FFF2-40B4-BE49-F238E27FC236}">
                <a16:creationId xmlns:a16="http://schemas.microsoft.com/office/drawing/2014/main" id="{FAEEABFF-A6AC-33C1-E9B1-81D42130D9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7152" y="116617"/>
            <a:ext cx="75693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2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6873" name="Rectangle 6">
            <a:extLst>
              <a:ext uri="{FF2B5EF4-FFF2-40B4-BE49-F238E27FC236}">
                <a16:creationId xmlns:a16="http://schemas.microsoft.com/office/drawing/2014/main" id="{BD752FBB-69CC-B240-D734-4DA3DC9301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3139" y="122967"/>
            <a:ext cx="75693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2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36874" name="Picture 6" descr="http://ebcdih.mc.vanderbilt.edu/dih/dih_files/snapshots/snapshot-190819-143117-1865772677.jpg">
            <a:extLst>
              <a:ext uri="{FF2B5EF4-FFF2-40B4-BE49-F238E27FC236}">
                <a16:creationId xmlns:a16="http://schemas.microsoft.com/office/drawing/2014/main" id="{F3E6E98D-7CAF-D821-7CD0-262BE4255C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05" t="52795"/>
          <a:stretch>
            <a:fillRect/>
          </a:stretch>
        </p:blipFill>
        <p:spPr bwMode="auto">
          <a:xfrm>
            <a:off x="7963414" y="116617"/>
            <a:ext cx="3071813" cy="2967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75" name="Rectangle 6">
            <a:extLst>
              <a:ext uri="{FF2B5EF4-FFF2-40B4-BE49-F238E27FC236}">
                <a16:creationId xmlns:a16="http://schemas.microsoft.com/office/drawing/2014/main" id="{B4CBA58B-C98E-33E0-BCCE-BCD4E0FAA8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50801" y="93422"/>
            <a:ext cx="75693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2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6876" name="Rectangle 26">
            <a:extLst>
              <a:ext uri="{FF2B5EF4-FFF2-40B4-BE49-F238E27FC236}">
                <a16:creationId xmlns:a16="http://schemas.microsoft.com/office/drawing/2014/main" id="{8CBD4791-2546-2200-4A8A-DC0E50CCBB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65946" y="2808872"/>
            <a:ext cx="55015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H460</a:t>
            </a:r>
          </a:p>
        </p:txBody>
      </p:sp>
      <p:pic>
        <p:nvPicPr>
          <p:cNvPr id="36877" name="Picture 8" descr="http://ebcdih.mc.vanderbilt.edu/dih/dih_files/snapshots/snapshot-190819-144021-1481935853.jpg">
            <a:extLst>
              <a:ext uri="{FF2B5EF4-FFF2-40B4-BE49-F238E27FC236}">
                <a16:creationId xmlns:a16="http://schemas.microsoft.com/office/drawing/2014/main" id="{AFCC4E3B-BFDD-8EB2-1FE5-7720994F49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05" t="52795"/>
          <a:stretch>
            <a:fillRect/>
          </a:stretch>
        </p:blipFill>
        <p:spPr bwMode="auto">
          <a:xfrm>
            <a:off x="1037152" y="3280505"/>
            <a:ext cx="3071812" cy="2967037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  <p:pic>
        <p:nvPicPr>
          <p:cNvPr id="36878" name="Picture 10" descr="http://ebcdih.mc.vanderbilt.edu/dih/dih_files/snapshots/snapshot-190819-144346-355303812.jpg">
            <a:extLst>
              <a:ext uri="{FF2B5EF4-FFF2-40B4-BE49-F238E27FC236}">
                <a16:creationId xmlns:a16="http://schemas.microsoft.com/office/drawing/2014/main" id="{DD87E89B-74A4-5272-DB05-5E1B7DF87E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05" t="52795"/>
          <a:stretch>
            <a:fillRect/>
          </a:stretch>
        </p:blipFill>
        <p:spPr bwMode="auto">
          <a:xfrm>
            <a:off x="4493139" y="3280505"/>
            <a:ext cx="3071813" cy="2967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79" name="Rectangle 27">
            <a:extLst>
              <a:ext uri="{FF2B5EF4-FFF2-40B4-BE49-F238E27FC236}">
                <a16:creationId xmlns:a16="http://schemas.microsoft.com/office/drawing/2014/main" id="{9E04761E-C9C1-0BA3-5946-4BE51D098E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3379" y="5976404"/>
            <a:ext cx="542136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A549</a:t>
            </a:r>
          </a:p>
        </p:txBody>
      </p:sp>
      <p:sp>
        <p:nvSpPr>
          <p:cNvPr id="36880" name="Rectangle 28">
            <a:extLst>
              <a:ext uri="{FF2B5EF4-FFF2-40B4-BE49-F238E27FC236}">
                <a16:creationId xmlns:a16="http://schemas.microsoft.com/office/drawing/2014/main" id="{9D66DA75-A144-5246-0D20-1E55D4FB5C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9769" y="5969486"/>
            <a:ext cx="55015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H520</a:t>
            </a:r>
          </a:p>
        </p:txBody>
      </p:sp>
      <p:sp>
        <p:nvSpPr>
          <p:cNvPr id="36881" name="Rectangle 6">
            <a:extLst>
              <a:ext uri="{FF2B5EF4-FFF2-40B4-BE49-F238E27FC236}">
                <a16:creationId xmlns:a16="http://schemas.microsoft.com/office/drawing/2014/main" id="{FB94FB53-07F9-B70E-D0E2-6B6D0C40A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3139" y="3279088"/>
            <a:ext cx="75693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1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6882" name="Rectangle 6">
            <a:extLst>
              <a:ext uri="{FF2B5EF4-FFF2-40B4-BE49-F238E27FC236}">
                <a16:creationId xmlns:a16="http://schemas.microsoft.com/office/drawing/2014/main" id="{0CAB3015-88E1-A12C-4C8D-F2C15EE7BB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0497" y="3279360"/>
            <a:ext cx="75693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1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482D18D-ED3C-CAE7-69B0-2B22207384E4}"/>
              </a:ext>
            </a:extLst>
          </p:cNvPr>
          <p:cNvSpPr txBox="1"/>
          <p:nvPr/>
        </p:nvSpPr>
        <p:spPr>
          <a:xfrm>
            <a:off x="1972790" y="6329747"/>
            <a:ext cx="69673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S1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ja-JP" altLang="en-US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presentative image of EPPK1 protein expression in cancer cell line microarrays (20x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algn="l">
          <a:defRPr dirty="0">
            <a:cs typeface="Arial" panose="020B0604020202020204" pitchFamily="34" charset="0"/>
          </a:defRPr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4</Words>
  <Application>Microsoft Macintosh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1_Office ​​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健</dc:creator>
  <cp:lastModifiedBy>Author</cp:lastModifiedBy>
  <cp:revision>1</cp:revision>
  <dcterms:created xsi:type="dcterms:W3CDTF">2023-05-15T06:54:30Z</dcterms:created>
  <dcterms:modified xsi:type="dcterms:W3CDTF">2023-09-08T15:08:58Z</dcterms:modified>
</cp:coreProperties>
</file>